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AB513-D539-4C96-B907-BD425C1A95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E74E3-E9D1-4FAD-B8B4-5ED52540B3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779B5-B4D9-4904-B175-44C01F6FCB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34D3D-154B-454D-9408-55B0623E34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4793A-5BAD-47F1-85AF-22249CE051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0B516-C640-4F5A-A7A8-446A23E91E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FD118E-D5BE-4CA3-9BDB-5B40EF087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0CB51-C63C-4FD4-B613-C1F52ABE01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E34D0-031E-4273-B982-60766EF234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4C5F9-0CFB-4B8E-8A66-467DD40760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4566D-BBAC-4422-91BE-A2568D3673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BF248-5222-4C01-AE2C-5B1FE09B8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216172-5C29-4FFE-B77A-201E2A6E502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343880" y="180720"/>
            <a:ext cx="3921480" cy="6552720"/>
            <a:chOff x="1343880" y="180720"/>
            <a:chExt cx="3921480" cy="6552720"/>
          </a:xfrm>
        </p:grpSpPr>
        <p:grpSp>
          <p:nvGrpSpPr>
            <p:cNvPr id="42" name=""/>
            <p:cNvGrpSpPr/>
            <p:nvPr/>
          </p:nvGrpSpPr>
          <p:grpSpPr>
            <a:xfrm>
              <a:off x="1343880" y="202320"/>
              <a:ext cx="3511800" cy="3403800"/>
              <a:chOff x="1343880" y="202320"/>
              <a:chExt cx="3511800" cy="3403800"/>
            </a:xfrm>
          </p:grpSpPr>
          <p:sp>
            <p:nvSpPr>
              <p:cNvPr id="43" name=""/>
              <p:cNvSpPr/>
              <p:nvPr/>
            </p:nvSpPr>
            <p:spPr>
              <a:xfrm>
                <a:off x="1343880" y="2135520"/>
                <a:ext cx="182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V="1">
                <a:off x="1526400" y="202320"/>
                <a:ext cx="0" cy="1933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526400" y="202320"/>
                <a:ext cx="558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V="1">
                <a:off x="1526400" y="534600"/>
                <a:ext cx="0" cy="1600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526400" y="534960"/>
                <a:ext cx="300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1827000" y="438480"/>
                <a:ext cx="0" cy="9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827000" y="438480"/>
                <a:ext cx="332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2160000" y="36324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160000" y="363240"/>
                <a:ext cx="77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2933280" y="266760"/>
                <a:ext cx="0" cy="9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933280" y="266760"/>
                <a:ext cx="35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933280" y="36324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933280" y="438480"/>
                <a:ext cx="64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2997720" y="36324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997720" y="36324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3040920" y="3200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040920" y="320400"/>
                <a:ext cx="182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040920" y="3632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040920" y="406440"/>
                <a:ext cx="106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V="1">
                <a:off x="3148200" y="3740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148200" y="37440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148200" y="40644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3148200" y="42768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997720" y="43848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997720" y="513360"/>
                <a:ext cx="128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3126600" y="492480"/>
                <a:ext cx="0" cy="20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126600" y="492480"/>
                <a:ext cx="118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126600" y="51336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126600" y="54576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160000" y="438480"/>
                <a:ext cx="0" cy="160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160000" y="599400"/>
                <a:ext cx="2523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827000" y="534960"/>
                <a:ext cx="0" cy="150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827000" y="685440"/>
                <a:ext cx="687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V="1">
                <a:off x="2514240" y="65304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514240" y="653040"/>
                <a:ext cx="128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514240" y="6854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514240" y="717480"/>
                <a:ext cx="182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526400" y="2135520"/>
                <a:ext cx="0" cy="147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526400" y="3606120"/>
                <a:ext cx="429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V="1">
                <a:off x="1955880" y="1801800"/>
                <a:ext cx="0" cy="1803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955880" y="180216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2052360" y="814320"/>
                <a:ext cx="0" cy="987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052360" y="814320"/>
                <a:ext cx="633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V="1">
                <a:off x="2685960" y="77076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685960" y="771120"/>
                <a:ext cx="558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685960" y="81432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685960" y="857160"/>
                <a:ext cx="397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V="1">
                <a:off x="3083400" y="8247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3083400" y="825120"/>
                <a:ext cx="236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3083400" y="85716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083400" y="878760"/>
                <a:ext cx="397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052360" y="1802160"/>
                <a:ext cx="0" cy="698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052360" y="2500200"/>
                <a:ext cx="290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2342520" y="2220480"/>
                <a:ext cx="0" cy="279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342520" y="2220840"/>
                <a:ext cx="375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2718720" y="2027880"/>
                <a:ext cx="0" cy="192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718720" y="2027880"/>
                <a:ext cx="1621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4340160" y="1726560"/>
                <a:ext cx="0" cy="30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340160" y="1726920"/>
                <a:ext cx="107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4447800" y="1405080"/>
                <a:ext cx="0" cy="32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447800" y="1405080"/>
                <a:ext cx="192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4641120" y="1179360"/>
                <a:ext cx="0" cy="225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641120" y="117936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4651560" y="1039680"/>
                <a:ext cx="0" cy="139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4651560" y="10400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V="1">
                <a:off x="4651560" y="98640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651560" y="9864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V="1">
                <a:off x="4651560" y="9428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651560" y="9432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4651560" y="98640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4651560" y="102888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4673160" y="99648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4673160" y="9968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4673160" y="102888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673160" y="105048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4651560" y="1040040"/>
                <a:ext cx="0" cy="64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651560" y="11044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651560" y="1179360"/>
                <a:ext cx="0" cy="128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4651560" y="130824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V="1">
                <a:off x="4662720" y="1211400"/>
                <a:ext cx="0" cy="9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662720" y="121140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V="1">
                <a:off x="4694760" y="116820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694760" y="11685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4694760" y="121140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4694760" y="124416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4716000" y="122220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716000" y="12225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716000" y="12441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716000" y="127620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662720" y="1308240"/>
                <a:ext cx="0" cy="96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662720" y="140508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4759200" y="13618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759200" y="13622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V="1">
                <a:off x="4759200" y="132984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759200" y="13298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4759200" y="13622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759200" y="13942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759200" y="140508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4759200" y="14479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4641120" y="1405080"/>
                <a:ext cx="0" cy="225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641120" y="163044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V="1">
                <a:off x="4651560" y="1533960"/>
                <a:ext cx="0" cy="9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651560" y="153396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V="1">
                <a:off x="4683960" y="15015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4683960" y="150192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4683960" y="153396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4683960" y="155520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651560" y="1630440"/>
                <a:ext cx="0" cy="107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651560" y="173808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 flipV="1">
                <a:off x="4683960" y="168372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683960" y="168408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V="1">
                <a:off x="4694760" y="164124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4694760" y="16412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V="1">
                <a:off x="4716000" y="161964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4716000" y="16200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4716000" y="16412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716000" y="167328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4694760" y="16840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694760" y="172692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683960" y="17380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4683960" y="178092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4447800" y="1726920"/>
                <a:ext cx="0" cy="30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4447800" y="202788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 flipV="1">
                <a:off x="4479840" y="1844640"/>
                <a:ext cx="0" cy="182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4479840" y="1845000"/>
                <a:ext cx="107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4479840" y="2027880"/>
                <a:ext cx="0" cy="192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4479840" y="222084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V="1">
                <a:off x="4555080" y="214596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4555080" y="2145960"/>
                <a:ext cx="64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V="1">
                <a:off x="4619520" y="205956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4619520" y="205992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4651560" y="1963080"/>
                <a:ext cx="0" cy="9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4651560" y="196308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V="1">
                <a:off x="4673160" y="1899000"/>
                <a:ext cx="0" cy="64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4673160" y="1899000"/>
                <a:ext cx="128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4673160" y="1963080"/>
                <a:ext cx="0" cy="64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4673160" y="202788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V="1">
                <a:off x="4683960" y="198432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4683960" y="198468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V="1">
                <a:off x="4694760" y="195228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4694760" y="19526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4694760" y="198468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4694760" y="200628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4683960" y="20278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683960" y="2070720"/>
                <a:ext cx="85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4651560" y="205992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651560" y="214596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flipV="1">
                <a:off x="4683960" y="212400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4683960" y="21243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4683960" y="214596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4683960" y="21783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4619520" y="214596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4619520" y="223200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4555080" y="2220840"/>
                <a:ext cx="0" cy="64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4555080" y="228564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4340160" y="2027880"/>
                <a:ext cx="0" cy="32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340160" y="2350080"/>
                <a:ext cx="182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2718720" y="2220840"/>
                <a:ext cx="0" cy="182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2718720" y="2403720"/>
                <a:ext cx="1675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2342520" y="2500200"/>
                <a:ext cx="0" cy="279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2342520" y="2779560"/>
                <a:ext cx="35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V="1">
                <a:off x="2697120" y="2499840"/>
                <a:ext cx="0" cy="279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2697120" y="2500200"/>
                <a:ext cx="805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V="1">
                <a:off x="3502440" y="245700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3502440" y="2457360"/>
                <a:ext cx="418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3502440" y="250020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3502440" y="2543400"/>
                <a:ext cx="332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V="1">
                <a:off x="3835440" y="251100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3835440" y="25113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3835440" y="254340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3835440" y="2575440"/>
                <a:ext cx="708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2697120" y="2779560"/>
                <a:ext cx="0" cy="204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2697120" y="2983680"/>
                <a:ext cx="204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V="1">
                <a:off x="2901240" y="2768760"/>
                <a:ext cx="0" cy="214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2901240" y="276876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V="1">
                <a:off x="2954880" y="271476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2954880" y="2715120"/>
                <a:ext cx="719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 flipV="1">
                <a:off x="3674520" y="266148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3674520" y="266148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 flipV="1">
                <a:off x="3771000" y="262908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3771000" y="262944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3771000" y="266148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3771000" y="268272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3674520" y="271512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3674520" y="2768760"/>
                <a:ext cx="118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 flipV="1">
                <a:off x="3792600" y="273636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3792600" y="273636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3792600" y="27687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3792600" y="280116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2954880" y="2768760"/>
                <a:ext cx="0" cy="85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520" bIns="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2954880" y="2854440"/>
                <a:ext cx="190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2901240" y="2983680"/>
                <a:ext cx="0" cy="257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2901240" y="3241440"/>
                <a:ext cx="397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 flipV="1">
                <a:off x="3298680" y="2908440"/>
                <a:ext cx="0" cy="33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3298680" y="2908440"/>
                <a:ext cx="1170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3298680" y="3241440"/>
                <a:ext cx="0" cy="214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3298680" y="3456000"/>
                <a:ext cx="128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V="1">
                <a:off x="3427200" y="3123360"/>
                <a:ext cx="0" cy="33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3427200" y="3123360"/>
                <a:ext cx="204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 flipV="1">
                <a:off x="3631680" y="3015720"/>
                <a:ext cx="0" cy="107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3" name=""/>
            <p:cNvGrpSpPr/>
            <p:nvPr/>
          </p:nvGrpSpPr>
          <p:grpSpPr>
            <a:xfrm>
              <a:off x="1956240" y="2962440"/>
              <a:ext cx="2974680" cy="3554640"/>
              <a:chOff x="1956240" y="2962440"/>
              <a:chExt cx="2974680" cy="3554640"/>
            </a:xfrm>
          </p:grpSpPr>
          <p:sp>
            <p:nvSpPr>
              <p:cNvPr id="244" name=""/>
              <p:cNvSpPr/>
              <p:nvPr/>
            </p:nvSpPr>
            <p:spPr>
              <a:xfrm>
                <a:off x="3631680" y="3015720"/>
                <a:ext cx="64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 flipV="1">
                <a:off x="3696120" y="296244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3696120" y="2962440"/>
                <a:ext cx="64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3696120" y="301572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3696120" y="3069720"/>
                <a:ext cx="42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 flipV="1">
                <a:off x="3738960" y="302652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3738960" y="3026880"/>
                <a:ext cx="53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3738960" y="306972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3738960" y="311256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 flipV="1">
                <a:off x="3749760" y="30801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3749760" y="308052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3749760" y="311256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3749760" y="313380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3631680" y="3123360"/>
                <a:ext cx="0" cy="106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3631680" y="323064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 flipV="1">
                <a:off x="3674880" y="318780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3674880" y="3187800"/>
                <a:ext cx="118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3674880" y="32306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3674880" y="3273480"/>
                <a:ext cx="321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 flipV="1">
                <a:off x="3996720" y="325188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3996720" y="32522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3996720" y="327348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3996720" y="330624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3427560" y="3456360"/>
                <a:ext cx="0" cy="30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3427560" y="3756960"/>
                <a:ext cx="64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 flipV="1">
                <a:off x="3492000" y="3456000"/>
                <a:ext cx="0" cy="30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3492000" y="3456360"/>
                <a:ext cx="118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 flipV="1">
                <a:off x="3610080" y="340272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3610080" y="3402720"/>
                <a:ext cx="128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 flipV="1">
                <a:off x="3738960" y="335916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3738960" y="3359520"/>
                <a:ext cx="483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3738960" y="340272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3738960" y="3445560"/>
                <a:ext cx="86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 flipV="1">
                <a:off x="3825000" y="341316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3825000" y="3413160"/>
                <a:ext cx="429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3825000" y="34455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3825000" y="3477600"/>
                <a:ext cx="182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3610080" y="345636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3610080" y="3531240"/>
                <a:ext cx="1320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3492000" y="3756960"/>
                <a:ext cx="0" cy="30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3492000" y="405792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 flipV="1">
                <a:off x="3567240" y="3713760"/>
                <a:ext cx="0" cy="34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3567240" y="3714120"/>
                <a:ext cx="118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 flipV="1">
                <a:off x="3685320" y="362772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3685320" y="362808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 flipV="1">
                <a:off x="3728160" y="358524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3728160" y="358524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3728160" y="36280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3728160" y="3670920"/>
                <a:ext cx="9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 flipV="1">
                <a:off x="3825000" y="363852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3825000" y="363888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3825000" y="367092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3825000" y="370332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3685320" y="371412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3685320" y="380016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 flipV="1">
                <a:off x="3706920" y="375660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3706920" y="3756960"/>
                <a:ext cx="246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3706920" y="380016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3706920" y="3843000"/>
                <a:ext cx="279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 flipV="1">
                <a:off x="3985920" y="381060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3985920" y="381060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3985920" y="3843000"/>
                <a:ext cx="0" cy="20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3985920" y="3864240"/>
                <a:ext cx="150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3567240" y="4057920"/>
                <a:ext cx="0" cy="33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3567240" y="4390560"/>
                <a:ext cx="64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 flipV="1">
                <a:off x="3631680" y="4261680"/>
                <a:ext cx="0" cy="128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3631680" y="426168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 flipV="1">
                <a:off x="3685320" y="4164840"/>
                <a:ext cx="0" cy="9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3685320" y="416484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 flipV="1">
                <a:off x="3696120" y="4035960"/>
                <a:ext cx="0" cy="128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3696120" y="403632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 flipV="1">
                <a:off x="3706920" y="394992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3706920" y="395028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 flipV="1">
                <a:off x="3749760" y="392832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3749760" y="392868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3749760" y="395028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3749760" y="398268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3706920" y="4036320"/>
                <a:ext cx="0" cy="85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520" bIns="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3706920" y="412200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 flipV="1">
                <a:off x="3728160" y="406836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3728160" y="406836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 flipV="1">
                <a:off x="3771360" y="40359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3771360" y="4036320"/>
                <a:ext cx="64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3771360" y="406836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3771360" y="408996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3728160" y="412200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3728160" y="4176000"/>
                <a:ext cx="192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 flipV="1">
                <a:off x="3921480" y="415404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3921480" y="415440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3921480" y="417600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3921480" y="420804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3696120" y="4164840"/>
                <a:ext cx="0" cy="128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3696120" y="4294080"/>
                <a:ext cx="42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flipV="1">
                <a:off x="3738960" y="426168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3738960" y="42616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3738960" y="429408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3738960" y="43156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3685320" y="4261680"/>
                <a:ext cx="0" cy="118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3685320" y="4379760"/>
                <a:ext cx="107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3631680" y="4390560"/>
                <a:ext cx="0" cy="107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3631680" y="449820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 flipV="1">
                <a:off x="3642120" y="4433400"/>
                <a:ext cx="0" cy="64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3642120" y="4433760"/>
                <a:ext cx="150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3642120" y="449820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3642120" y="45734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 flipV="1">
                <a:off x="3663720" y="4487040"/>
                <a:ext cx="0" cy="8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3663720" y="448740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3663720" y="457344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3663720" y="464832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flipV="1">
                <a:off x="3674880" y="457344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3674880" y="457344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V="1">
                <a:off x="3728160" y="454068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3728160" y="454068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3728160" y="45734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3728160" y="46054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3674880" y="464832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3674880" y="472356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 flipV="1">
                <a:off x="3685320" y="4658760"/>
                <a:ext cx="0" cy="64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3685320" y="465912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3685320" y="4723560"/>
                <a:ext cx="0" cy="7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3685320" y="479844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 flipV="1">
                <a:off x="3696120" y="474516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3696120" y="47451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 flipV="1">
                <a:off x="3696120" y="471276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3696120" y="47131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3696120" y="474516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3696120" y="47664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3696120" y="479844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3696120" y="48524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 flipV="1">
                <a:off x="3696120" y="482004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3696120" y="48200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3696120" y="48524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3696120" y="48844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1956240" y="3606480"/>
                <a:ext cx="0" cy="291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1956240" y="6517080"/>
                <a:ext cx="418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 flipV="1">
                <a:off x="2374920" y="6355800"/>
                <a:ext cx="0" cy="160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2374920" y="635616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 flipV="1">
                <a:off x="2450160" y="6054840"/>
                <a:ext cx="0" cy="300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2450160" y="6055200"/>
                <a:ext cx="300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V="1">
                <a:off x="2750760" y="5862240"/>
                <a:ext cx="0" cy="192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2750760" y="586224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 flipV="1">
                <a:off x="2761920" y="5743800"/>
                <a:ext cx="0" cy="118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2761920" y="5743800"/>
                <a:ext cx="42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 flipV="1">
                <a:off x="2804400" y="5593320"/>
                <a:ext cx="0" cy="150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2804400" y="5593320"/>
                <a:ext cx="86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 flipV="1">
                <a:off x="2890440" y="5464440"/>
                <a:ext cx="0" cy="128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2890440" y="546480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 flipV="1">
                <a:off x="2912040" y="5292720"/>
                <a:ext cx="0" cy="172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2912040" y="529272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 flipV="1">
                <a:off x="2922840" y="5152680"/>
                <a:ext cx="0" cy="139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2922840" y="5153040"/>
                <a:ext cx="32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 flipV="1">
                <a:off x="2954880" y="5023800"/>
                <a:ext cx="0" cy="128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2954880" y="5024160"/>
                <a:ext cx="53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 flipV="1">
                <a:off x="3008520" y="497052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3008520" y="4970520"/>
                <a:ext cx="74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 flipV="1">
                <a:off x="3083760" y="493812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3083760" y="49381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3083760" y="497052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3083760" y="49921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3008520" y="502416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3008520" y="507780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 flipV="1">
                <a:off x="3030120" y="504540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3030120" y="50457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3030120" y="507780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3030120" y="51102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2954880" y="5153040"/>
                <a:ext cx="0" cy="128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2954880" y="5281920"/>
                <a:ext cx="128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 flipV="1">
                <a:off x="3083760" y="522828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3083760" y="52282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 flipV="1">
                <a:off x="3083760" y="519588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3083760" y="51958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 flipV="1">
                <a:off x="3083760" y="516348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3083760" y="51638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3083760" y="5195880"/>
                <a:ext cx="0" cy="21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560" bIns="-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3083760" y="52174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3083760" y="522828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3083760" y="52714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3083760" y="5281920"/>
                <a:ext cx="0" cy="53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3083760" y="53355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2922840" y="5292720"/>
                <a:ext cx="0" cy="139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2922840" y="5432040"/>
                <a:ext cx="42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 flipV="1">
                <a:off x="2965680" y="5389560"/>
                <a:ext cx="0" cy="42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2965680" y="538956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2965680" y="5432040"/>
                <a:ext cx="0" cy="53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2965680" y="54860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 flipV="1">
                <a:off x="2986920" y="54428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2986920" y="5443200"/>
                <a:ext cx="10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2986920" y="5486040"/>
                <a:ext cx="0" cy="42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2986920" y="5529240"/>
                <a:ext cx="21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 flipV="1">
                <a:off x="3008520" y="549684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3008520" y="5496840"/>
                <a:ext cx="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3008520" y="5529240"/>
                <a:ext cx="0" cy="32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3008520" y="55612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2912040" y="5464800"/>
                <a:ext cx="0" cy="182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2912040" y="5647320"/>
                <a:ext cx="42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 flipV="1">
                <a:off x="2954880" y="5614920"/>
                <a:ext cx="0" cy="32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0" bIns="-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2954880" y="56149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2954880" y="5647320"/>
                <a:ext cx="0" cy="20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2954880" y="56685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>
                <a:off x="2890440" y="5593320"/>
                <a:ext cx="0" cy="128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44" name=""/>
            <p:cNvSpPr/>
            <p:nvPr/>
          </p:nvSpPr>
          <p:spPr>
            <a:xfrm>
              <a:off x="2890800" y="5722920"/>
              <a:ext cx="74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2804760" y="5744160"/>
              <a:ext cx="0" cy="150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2804760" y="5894640"/>
              <a:ext cx="150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 flipV="1">
              <a:off x="2955240" y="585108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2955240" y="5851440"/>
              <a:ext cx="32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 flipV="1">
              <a:off x="2987280" y="580824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2987280" y="5808600"/>
              <a:ext cx="64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 flipV="1">
              <a:off x="3051720" y="5787360"/>
              <a:ext cx="0" cy="20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3051720" y="5787360"/>
              <a:ext cx="10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3051720" y="5808600"/>
              <a:ext cx="0" cy="32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3051720" y="5841000"/>
              <a:ext cx="118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2987280" y="585144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2987280" y="5894640"/>
              <a:ext cx="150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2955240" y="5894640"/>
              <a:ext cx="0" cy="53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2955240" y="5947920"/>
              <a:ext cx="24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2761920" y="5862600"/>
              <a:ext cx="0" cy="150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2761920" y="6012720"/>
              <a:ext cx="279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2751120" y="6055560"/>
              <a:ext cx="0" cy="1929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2751120" y="6248880"/>
              <a:ext cx="74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 flipV="1">
              <a:off x="2826000" y="6141240"/>
              <a:ext cx="0" cy="106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2826000" y="6141600"/>
              <a:ext cx="968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 flipV="1">
              <a:off x="2923200" y="6087240"/>
              <a:ext cx="0" cy="53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2923200" y="6087600"/>
              <a:ext cx="53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 flipV="1">
              <a:off x="2976840" y="6066000"/>
              <a:ext cx="0" cy="21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2976840" y="6066360"/>
              <a:ext cx="268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2976840" y="6087600"/>
              <a:ext cx="0" cy="32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2976840" y="6120360"/>
              <a:ext cx="536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2923200" y="6141600"/>
              <a:ext cx="0" cy="64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2923200" y="6205680"/>
              <a:ext cx="246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 flipV="1">
              <a:off x="3170160" y="6173280"/>
              <a:ext cx="0" cy="32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3170160" y="6173640"/>
              <a:ext cx="182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3170160" y="6205680"/>
              <a:ext cx="0" cy="32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3170160" y="6238440"/>
              <a:ext cx="204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2826000" y="6248880"/>
              <a:ext cx="0" cy="128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2826000" y="6378120"/>
              <a:ext cx="268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 flipV="1">
              <a:off x="3094920" y="6291360"/>
              <a:ext cx="0" cy="86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3094920" y="6291720"/>
              <a:ext cx="547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3094920" y="6378120"/>
              <a:ext cx="0" cy="96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3094920" y="6474600"/>
              <a:ext cx="805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 flipV="1">
              <a:off x="3900240" y="6388200"/>
              <a:ext cx="0" cy="86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3900240" y="6388560"/>
              <a:ext cx="676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 flipV="1">
              <a:off x="4577040" y="63450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4577040" y="6345360"/>
              <a:ext cx="74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4577040" y="638856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4577040" y="6431400"/>
              <a:ext cx="10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 flipV="1">
              <a:off x="4588200" y="6399000"/>
              <a:ext cx="0" cy="32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4588200" y="6399360"/>
              <a:ext cx="10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4588200" y="6431400"/>
              <a:ext cx="0" cy="32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4588200" y="646344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3900240" y="6474600"/>
              <a:ext cx="0" cy="64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3900240" y="6539040"/>
              <a:ext cx="107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 flipV="1">
              <a:off x="4007880" y="6517080"/>
              <a:ext cx="0" cy="21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4007880" y="6517440"/>
              <a:ext cx="15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4007880" y="6539040"/>
              <a:ext cx="0" cy="32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4007880" y="6571080"/>
              <a:ext cx="15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2450160" y="6356520"/>
              <a:ext cx="0" cy="268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2450160" y="6624720"/>
              <a:ext cx="139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2375280" y="6517440"/>
              <a:ext cx="0" cy="171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2375280" y="6689160"/>
              <a:ext cx="192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2094120" y="18072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432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3297240" y="2451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194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233520" y="29880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3G124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3254400" y="3528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11g34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3180240" y="4064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4g168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3254400" y="4708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5g414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3180240" y="5245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212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4694400" y="5781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466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2642040" y="6321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087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2707200" y="6962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052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3243240" y="7502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079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3319200" y="8038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3g635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3491640" y="8575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013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4662000" y="9219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4G272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4705200" y="97560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510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4693320" y="10292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3G206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4662000" y="10832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546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4693320" y="11365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7g361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4725720" y="12013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8g33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4759200" y="12549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253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4768560" y="130824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7g361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4768560" y="136224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12g2512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4769640" y="142668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25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4705200" y="14806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546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4714920" y="15339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088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4725720" y="15876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3g51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4736520" y="165204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12g345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4737600" y="170568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4g060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4705560" y="175968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103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4596840" y="181332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025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4811400" y="18777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598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4725720" y="19314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5g023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4780440" y="19850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663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4780440" y="20390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4g285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4693320" y="21031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31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4693320" y="21571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3g17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4662360" y="22107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663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4597920" y="22644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230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4533480" y="23288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624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4403520" y="23824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129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3930840" y="24364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2G274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3844800" y="24901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9g394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4544280" y="25545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4g385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3823560" y="260820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230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3812760" y="26618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081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3824280" y="27154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8g295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3878280" y="27799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349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4866120" y="28335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234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4478760" y="28875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2g494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3769920" y="29408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219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3801960" y="30056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476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3758760" y="30592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2g493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3771000" y="31125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56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3791520" y="31665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6g174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4028760" y="32328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434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4039200" y="32850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434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4232520" y="333828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3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4264920" y="33919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9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4017600" y="34459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3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4941720" y="35100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434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3812760" y="356400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2G478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3844800" y="361764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708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3845880" y="367128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600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3963240" y="373572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090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4038120" y="37893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708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4146840" y="38433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600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3781440" y="389700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2G370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3801960" y="39614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3G533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3844800" y="40150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618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3792600" y="40687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54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3973680" y="41223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5g497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3985560" y="41868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15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3738240" y="42408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5g3882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3738600" y="42944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2g229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3803040" y="4348080"/>
              <a:ext cx="5781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Arial"/>
                </a:rPr>
                <a:t>At2G38880_HAP3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3801960" y="441252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2G135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3715920" y="44679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476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3769920" y="45198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8g077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3738600" y="45738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56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3705120" y="46378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7g415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705120" y="46918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4G145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3705120" y="47451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3g299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3706200" y="47988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219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3706200" y="48636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600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3094200" y="4916880"/>
              <a:ext cx="5781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Arial"/>
                </a:rPr>
                <a:t>At3G48590_HAP5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3093840" y="49726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634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3039480" y="50245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3g1466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3040560" y="50893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679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3093840" y="51426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8g387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3093840" y="519624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9g303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3094200" y="52502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392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3094200" y="53143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4g332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2985480" y="53683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2g074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3007800" y="542196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6g456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3040560" y="54756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1g32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3018960" y="55400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052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2954160" y="55936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089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2954160" y="56476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548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2975040" y="57027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1G561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3072600" y="575496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3180240" y="581940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82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3147840" y="587304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8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3212280" y="592668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3g177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3050640" y="59806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8g105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3243240" y="604512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504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3522600" y="609876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504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3361320" y="615240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504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3382920" y="620784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279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3651840" y="6270480"/>
              <a:ext cx="3222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t5G381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4662000" y="63241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2446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4608000" y="63781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3985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4639680" y="64314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1g0129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4167360" y="649620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10g115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4156920" y="654948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5g2391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2599200" y="6603120"/>
              <a:ext cx="363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s04g5868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2578680" y="6657120"/>
              <a:ext cx="323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d5g26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9" name=""/>
          <p:cNvSpPr/>
          <p:nvPr/>
        </p:nvSpPr>
        <p:spPr>
          <a:xfrm>
            <a:off x="2498400" y="560088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2719440" y="5008680"/>
            <a:ext cx="293760" cy="9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2912760" y="516096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2511360" y="68904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2911320" y="73512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3724200" y="634680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4394160" y="625968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3620880" y="264312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3325680" y="237492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2757240" y="22860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2340000" y="56520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2531880" y="491004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2920680" y="484200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3466800" y="2589120"/>
            <a:ext cx="285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3752640" y="413244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4127400" y="1898640"/>
            <a:ext cx="285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4259160" y="120168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4443480" y="1287360"/>
            <a:ext cx="293760" cy="907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3247920" y="437688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3422520" y="4462560"/>
            <a:ext cx="293760" cy="9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3819240" y="3225960"/>
            <a:ext cx="2509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3619440" y="3625920"/>
            <a:ext cx="2858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 flipV="1">
            <a:off x="2676600" y="5667480"/>
            <a:ext cx="258840" cy="158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4427640" y="3933720"/>
            <a:ext cx="144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4572000" y="3933720"/>
            <a:ext cx="4680" cy="1017720"/>
          </a:xfrm>
          <a:custGeom>
            <a:avLst/>
            <a:gdLst/>
            <a:ahLst/>
            <a:rect l="l" t="t" r="r" b="b"/>
            <a:pathLst>
              <a:path w="3" h="641">
                <a:moveTo>
                  <a:pt x="0" y="1"/>
                </a:moveTo>
                <a:lnTo>
                  <a:pt x="2" y="0"/>
                </a:lnTo>
                <a:lnTo>
                  <a:pt x="3" y="641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3851280" y="4941720"/>
            <a:ext cx="4680" cy="809640"/>
          </a:xfrm>
          <a:custGeom>
            <a:avLst/>
            <a:gdLst/>
            <a:ahLst/>
            <a:rect l="l" t="t" r="r" b="b"/>
            <a:pathLst>
              <a:path w="3" h="510">
                <a:moveTo>
                  <a:pt x="3" y="0"/>
                </a:moveTo>
                <a:lnTo>
                  <a:pt x="3" y="507"/>
                </a:lnTo>
                <a:lnTo>
                  <a:pt x="0" y="504"/>
                </a:lnTo>
                <a:lnTo>
                  <a:pt x="2" y="510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4643280" y="4149720"/>
            <a:ext cx="1656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HAP3 clade selected for tree in figure 8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3995640" y="5084640"/>
            <a:ext cx="1656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HAP5 clade selected for tree in figure 8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6084720" y="549360"/>
            <a:ext cx="2519640" cy="157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00 datas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4427640" y="4941720"/>
            <a:ext cx="144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3710160" y="4954680"/>
            <a:ext cx="144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3710160" y="5745240"/>
            <a:ext cx="141120" cy="1440"/>
          </a:xfrm>
          <a:custGeom>
            <a:avLst/>
            <a:gdLst/>
            <a:ahLst/>
            <a:rect l="l" t="t" r="r" b="b"/>
            <a:pathLst>
              <a:path w="89" h="1">
                <a:moveTo>
                  <a:pt x="0" y="1"/>
                </a:moveTo>
                <a:lnTo>
                  <a:pt x="89" y="0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3T15:47:54Z</dcterms:created>
  <dc:creator>Janet Higgins</dc:creator>
  <dc:description/>
  <dc:language>en-US</dc:language>
  <cp:lastModifiedBy>Janet Higgins</cp:lastModifiedBy>
  <dcterms:modified xsi:type="dcterms:W3CDTF">2010-01-06T12:01:31Z</dcterms:modified>
  <cp:revision>4</cp:revision>
  <dc:subject/>
  <dc:title>Slide 1</dc:title>
</cp:coreProperties>
</file>